
<file path=[Content_Types].xml><?xml version="1.0" encoding="utf-8"?>
<Types xmlns="http://schemas.openxmlformats.org/package/2006/content-types">
  <Default Extension="jpeg" ContentType="image/jpeg"/>
  <Default Extension="jp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23"/>
  </p:notesMasterIdLst>
  <p:sldIdLst>
    <p:sldId id="256" r:id="rId2"/>
    <p:sldId id="258" r:id="rId3"/>
    <p:sldId id="259" r:id="rId4"/>
    <p:sldId id="260" r:id="rId5"/>
    <p:sldId id="261" r:id="rId6"/>
    <p:sldId id="262" r:id="rId7"/>
    <p:sldId id="311" r:id="rId8"/>
    <p:sldId id="299" r:id="rId9"/>
    <p:sldId id="300" r:id="rId10"/>
    <p:sldId id="301" r:id="rId11"/>
    <p:sldId id="302" r:id="rId12"/>
    <p:sldId id="303" r:id="rId13"/>
    <p:sldId id="313" r:id="rId14"/>
    <p:sldId id="304" r:id="rId15"/>
    <p:sldId id="297" r:id="rId16"/>
    <p:sldId id="264" r:id="rId17"/>
    <p:sldId id="265" r:id="rId18"/>
    <p:sldId id="268" r:id="rId19"/>
    <p:sldId id="312" r:id="rId20"/>
    <p:sldId id="269" r:id="rId21"/>
    <p:sldId id="314" r:id="rId2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7875"/>
    <p:restoredTop sz="90169"/>
  </p:normalViewPr>
  <p:slideViewPr>
    <p:cSldViewPr snapToGrid="0">
      <p:cViewPr varScale="1">
        <p:scale>
          <a:sx n="96" d="100"/>
          <a:sy n="96" d="100"/>
        </p:scale>
        <p:origin x="36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B11A8CD-9364-9649-95ED-6185C44261DB}" type="datetimeFigureOut">
              <a:rPr lang="en-US" smtClean="0"/>
              <a:t>7/26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9DCA785-1F10-BE41-856C-6D7BB126B0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7500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Media source: Valleywise Health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0" i="0" u="none" strike="noStrike" dirty="0">
                <a:solidFill>
                  <a:srgbClr val="1E1E1E"/>
                </a:solidFill>
                <a:effectLst/>
                <a:latin typeface="Helvetica Neue" panose="02000503000000020004" pitchFamily="2" charset="0"/>
              </a:rPr>
              <a:t>Stimulus 1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9DCA785-1F10-BE41-856C-6D7BB126B06F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0886920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Media source: Valleywise Health </a:t>
            </a:r>
          </a:p>
          <a:p>
            <a:r>
              <a:rPr lang="en-US" dirty="0"/>
              <a:t>Stimulus 7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9DCA785-1F10-BE41-856C-6D7BB126B06F}" type="slidenum">
              <a:rPr lang="en-US" smtClean="0"/>
              <a:t>1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3541671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Media source: Valleywise Health </a:t>
            </a:r>
          </a:p>
          <a:p>
            <a:r>
              <a:rPr lang="en-US" dirty="0"/>
              <a:t>Stimulus 8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9DCA785-1F10-BE41-856C-6D7BB126B06F}" type="slidenum">
              <a:rPr lang="en-US" smtClean="0"/>
              <a:t>2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4457121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Media source: Valleywise Health </a:t>
            </a:r>
          </a:p>
          <a:p>
            <a:r>
              <a:rPr lang="en-US" dirty="0"/>
              <a:t>Stimulus 9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9DCA785-1F10-BE41-856C-6D7BB126B06F}" type="slidenum">
              <a:rPr lang="en-US" smtClean="0"/>
              <a:t>2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566448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Media source: </a:t>
            </a:r>
            <a:r>
              <a:rPr lang="en-US" dirty="0" err="1"/>
              <a:t>Valleywise</a:t>
            </a:r>
            <a:r>
              <a:rPr lang="en-US" dirty="0"/>
              <a:t> Health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0" i="0" u="none" strike="noStrike" dirty="0">
                <a:solidFill>
                  <a:srgbClr val="1E1E1E"/>
                </a:solidFill>
                <a:effectLst/>
                <a:latin typeface="Helvetica Neue" panose="02000503000000020004" pitchFamily="2" charset="0"/>
              </a:rPr>
              <a:t>Stimulus 2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9DCA785-1F10-BE41-856C-6D7BB126B06F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204091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Media source: Valleywise Health </a:t>
            </a:r>
          </a:p>
          <a:p>
            <a:r>
              <a:rPr lang="en-US"/>
              <a:t>Stimulus 3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9DCA785-1F10-BE41-856C-6D7BB126B06F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562661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Media source: Valleywise Health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0" i="0" u="none" strike="noStrike" dirty="0">
                <a:solidFill>
                  <a:srgbClr val="1E1E1E"/>
                </a:solidFill>
                <a:effectLst/>
                <a:latin typeface="Helvetica Neue" panose="02000503000000020004" pitchFamily="2" charset="0"/>
              </a:rPr>
              <a:t>Stimulus 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9DCA785-1F10-BE41-856C-6D7BB126B06F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250437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Media source: Valleywise Health </a:t>
            </a:r>
          </a:p>
          <a:p>
            <a:r>
              <a:rPr lang="en-US" dirty="0"/>
              <a:t>Stimulus 4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9DCA785-1F10-BE41-856C-6D7BB126B06F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9396297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Media source: Valleywise Health </a:t>
            </a:r>
          </a:p>
          <a:p>
            <a:r>
              <a:rPr lang="en-US" dirty="0"/>
              <a:t>Stimulus 5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9DCA785-1F10-BE41-856C-6D7BB126B06F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1195888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9DCA785-1F10-BE41-856C-6D7BB126B06F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6821884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9DCA785-1F10-BE41-856C-6D7BB126B06F}" type="slidenum">
              <a:rPr lang="en-US" smtClean="0"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3326500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Media source: Valleywise Health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timulus 6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9DCA785-1F10-BE41-856C-6D7BB126B06F}" type="slidenum">
              <a:rPr lang="en-US" smtClean="0"/>
              <a:t>1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549812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96C426-07CF-03B8-855C-4304815236C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EF34630-1CC4-8485-F755-7A9EC5A11E8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FF369E-60A1-748A-928F-B0D872E061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E2BA5-FBAB-6F48-861E-7EF7BA7ACD57}" type="datetimeFigureOut">
              <a:rPr lang="en-US" smtClean="0"/>
              <a:t>7/2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3F7D17-36BB-73BC-266D-AFE4E5EDDB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C42814-37E1-9632-7443-2DF787F6D7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D5C3E2-68DA-4C40-8B29-B78291D7AC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67694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0AA2A7-BE2F-907F-F14E-FAF4E6F159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716C2B6-2C9C-9586-D2DE-B3852DAB408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53201D-3C83-E203-9BD0-F7070848BA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E2BA5-FBAB-6F48-861E-7EF7BA7ACD57}" type="datetimeFigureOut">
              <a:rPr lang="en-US" smtClean="0"/>
              <a:t>7/2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82605E-8A3C-FFB6-12EF-B4EB7853B0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D41806-244A-4812-2D3F-127AD1292D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D5C3E2-68DA-4C40-8B29-B78291D7AC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57998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0703A8E-00F4-AF24-7964-178B0D5E72F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D1A4B08-BC96-5ABF-777A-BDF57DC55C4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BDAEBD-125A-ECAE-915F-32B3EEC68D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E2BA5-FBAB-6F48-861E-7EF7BA7ACD57}" type="datetimeFigureOut">
              <a:rPr lang="en-US" smtClean="0"/>
              <a:t>7/2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17145F-3D6A-6C30-D063-7C1E74FC9F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7F1E57-76B4-C4F5-19DD-D4DD73C146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D5C3E2-68DA-4C40-8B29-B78291D7AC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349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E29DB6-9542-630B-0AD9-B812BB32A9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9007F2C-5F60-7AEC-77EE-0E6F0354884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AC707F-B9A5-11CA-96A3-6B06ECDACB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E2BA5-FBAB-6F48-861E-7EF7BA7ACD57}" type="datetimeFigureOut">
              <a:rPr lang="en-US" smtClean="0"/>
              <a:t>7/2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9A30071-AEBD-6963-F8C2-F526BBB305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D4CC47-5F19-01A7-AE12-F21B28DF42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D5C3E2-68DA-4C40-8B29-B78291D7AC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60910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CEE182-B121-C027-C1CA-65405BF1BD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307B46B-20F5-82F1-17CB-BA8D94058E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E7911F-C7EA-F071-AC2D-EB25EF92EA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E2BA5-FBAB-6F48-861E-7EF7BA7ACD57}" type="datetimeFigureOut">
              <a:rPr lang="en-US" smtClean="0"/>
              <a:t>7/2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FA8EED-53EA-F80D-A837-5D2F6C7FA5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57B592-ABC7-F193-B2F3-0657197F03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D5C3E2-68DA-4C40-8B29-B78291D7AC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27411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CE6DCC-853D-FE8C-FC04-200738F77B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795059-C823-BA4D-05EF-1A4AF6AFE3D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2609CE1-7741-27D9-E52E-B2E7ABEAA00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B81CB8A-211D-639B-7C6B-221201D0DF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E2BA5-FBAB-6F48-861E-7EF7BA7ACD57}" type="datetimeFigureOut">
              <a:rPr lang="en-US" smtClean="0"/>
              <a:t>7/26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FA00BA8-34C4-BC35-AAF1-472AAA21E0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2D24124-AE19-CCA9-BB33-0ED3042723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D5C3E2-68DA-4C40-8B29-B78291D7AC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14793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943E83-732E-9EAA-0AAB-B2E208A919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C9F4660-464B-DC11-A839-19965F79A3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49BD13C-4899-6F4F-62DA-E1F7C5DA608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EDD0508-43F9-3914-2BBD-D727936338C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436EAC1-5C69-A02D-84F5-8A70F0F01D6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81EE5C8-0639-95C1-348E-9899469AE9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E2BA5-FBAB-6F48-861E-7EF7BA7ACD57}" type="datetimeFigureOut">
              <a:rPr lang="en-US" smtClean="0"/>
              <a:t>7/26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0D1BEF3-D921-AF69-E24A-B350A0E45D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7DC148E-748B-ABF1-3F38-4AA4533CE3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D5C3E2-68DA-4C40-8B29-B78291D7AC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51373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5BAFB5-F7AA-7971-7A88-85D052DA2D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31C2B65-80DF-0F08-07D9-9086A6ED5F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E2BA5-FBAB-6F48-861E-7EF7BA7ACD57}" type="datetimeFigureOut">
              <a:rPr lang="en-US" smtClean="0"/>
              <a:t>7/26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5E9D452-B8D0-17DE-129A-275340DD97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CA10A6E-B7C7-4402-776F-857C726894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D5C3E2-68DA-4C40-8B29-B78291D7AC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50056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F7ADB4A-4EAF-28AA-8766-67366F28D5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E2BA5-FBAB-6F48-861E-7EF7BA7ACD57}" type="datetimeFigureOut">
              <a:rPr lang="en-US" smtClean="0"/>
              <a:t>7/26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1493BF1-A3EE-CB5B-D5F1-66B8577B3B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F591F04-C190-829A-B79B-1CB80425A2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D5C3E2-68DA-4C40-8B29-B78291D7AC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21071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712A6C-C391-D26D-8235-6F5D166611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4B8B195-9101-13E8-7D91-92CB1788CD6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17199BB-2B80-162B-6657-9ECBE6A127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A88126E-13B1-DD36-7776-2103FEF6FA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E2BA5-FBAB-6F48-861E-7EF7BA7ACD57}" type="datetimeFigureOut">
              <a:rPr lang="en-US" smtClean="0"/>
              <a:t>7/26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232E8FF-915B-F822-9E2E-51CF0E0527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08AFDA3-DB90-8CCD-3221-C9B2A30690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D5C3E2-68DA-4C40-8B29-B78291D7AC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66831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B8D14D-50A2-310E-1838-88C1AEB87C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2990E0A-E11A-8E7B-D396-D0A769BAB64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80E28D9-57E9-E422-DEA6-B940F098DB5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2483767-6B14-B34F-F4B0-1D9C1D62FF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E2BA5-FBAB-6F48-861E-7EF7BA7ACD57}" type="datetimeFigureOut">
              <a:rPr lang="en-US" smtClean="0"/>
              <a:t>7/26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56B9D7A-C836-16D4-BCF5-F2AAC4CC7D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C5FE65B-2BB4-099C-CA5F-5F9BE470C0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D5C3E2-68DA-4C40-8B29-B78291D7AC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88273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39706E1-290C-36F9-42B7-5F15A8FFD6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0A06243-6F31-7F8E-F7F9-5450CFE2CD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7A4879-1382-FB34-7BB9-D3BFCC8E9B7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FE2BA5-FBAB-6F48-861E-7EF7BA7ACD57}" type="datetimeFigureOut">
              <a:rPr lang="en-US" smtClean="0"/>
              <a:t>7/2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2EC98AB-A44B-A2E6-865E-E456368DFC0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72A50D-1796-A597-79A3-7F22B031809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D5C3E2-68DA-4C40-8B29-B78291D7AC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8793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5" Type="http://schemas.openxmlformats.org/officeDocument/2006/relationships/image" Target="../media/image1.png"/><Relationship Id="rId4" Type="http://schemas.openxmlformats.org/officeDocument/2006/relationships/notesSlide" Target="../notesSlides/notesSlide4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3.mp4"/><Relationship Id="rId1" Type="http://schemas.microsoft.com/office/2007/relationships/media" Target="../media/media3.mp4"/><Relationship Id="rId5" Type="http://schemas.openxmlformats.org/officeDocument/2006/relationships/image" Target="../media/image4.png"/><Relationship Id="rId4" Type="http://schemas.openxmlformats.org/officeDocument/2006/relationships/notesSlide" Target="../notesSlides/notesSlide5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4.mp4"/><Relationship Id="rId1" Type="http://schemas.microsoft.com/office/2007/relationships/media" Target="../media/media4.mp4"/><Relationship Id="rId5" Type="http://schemas.openxmlformats.org/officeDocument/2006/relationships/image" Target="../media/image6.png"/><Relationship Id="rId4" Type="http://schemas.openxmlformats.org/officeDocument/2006/relationships/notesSlide" Target="../notesSlides/notesSlide9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5.mp4"/><Relationship Id="rId1" Type="http://schemas.microsoft.com/office/2007/relationships/media" Target="../media/media5.mp4"/><Relationship Id="rId5" Type="http://schemas.openxmlformats.org/officeDocument/2006/relationships/image" Target="../media/image7.png"/><Relationship Id="rId4" Type="http://schemas.openxmlformats.org/officeDocument/2006/relationships/notesSlide" Target="../notesSlides/notesSlide10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6.mp4"/><Relationship Id="rId1" Type="http://schemas.microsoft.com/office/2007/relationships/media" Target="../media/media6.mp4"/><Relationship Id="rId5" Type="http://schemas.openxmlformats.org/officeDocument/2006/relationships/image" Target="../media/image8.png"/><Relationship Id="rId4" Type="http://schemas.openxmlformats.org/officeDocument/2006/relationships/notesSlide" Target="../notesSlides/notesSlide11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7.mp4"/><Relationship Id="rId1" Type="http://schemas.microsoft.com/office/2007/relationships/media" Target="../media/media7.mp4"/><Relationship Id="rId5" Type="http://schemas.openxmlformats.org/officeDocument/2006/relationships/image" Target="../media/image9.png"/><Relationship Id="rId4" Type="http://schemas.openxmlformats.org/officeDocument/2006/relationships/notesSlide" Target="../notesSlides/notesSlide1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5" Type="http://schemas.openxmlformats.org/officeDocument/2006/relationships/image" Target="../media/image1.png"/><Relationship Id="rId4" Type="http://schemas.openxmlformats.org/officeDocument/2006/relationships/notesSlide" Target="../notesSlides/notesSlide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2.mp4"/><Relationship Id="rId1" Type="http://schemas.microsoft.com/office/2007/relationships/media" Target="../media/media2.mp4"/><Relationship Id="rId5" Type="http://schemas.openxmlformats.org/officeDocument/2006/relationships/image" Target="../media/image3.png"/><Relationship Id="rId4" Type="http://schemas.openxmlformats.org/officeDocument/2006/relationships/notesSlide" Target="../notesSlides/notesSlide3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D63FB7-8DAB-215C-0446-04E5870EB420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b="1" dirty="0"/>
              <a:t>Transvaginal Ultrasound Simulation 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184B10D-1944-7C55-D3BA-8AD3A6CC678E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/>
              <a:t>Case Stimuli </a:t>
            </a:r>
          </a:p>
        </p:txBody>
      </p:sp>
    </p:spTree>
    <p:extLst>
      <p:ext uri="{BB962C8B-B14F-4D97-AF65-F5344CB8AC3E}">
        <p14:creationId xmlns:p14="http://schemas.microsoft.com/office/powerpoint/2010/main" val="206028176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33A2CE-9F34-F7C6-94A3-D34DD326C6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55721" y="257213"/>
            <a:ext cx="1406543" cy="1325563"/>
          </a:xfrm>
        </p:spPr>
        <p:txBody>
          <a:bodyPr/>
          <a:lstStyle/>
          <a:p>
            <a:r>
              <a:rPr lang="en-US" b="1" dirty="0"/>
              <a:t>Labs</a:t>
            </a:r>
          </a:p>
        </p:txBody>
      </p:sp>
      <p:sp>
        <p:nvSpPr>
          <p:cNvPr id="5" name="Content Placeholder 2">
            <a:extLst>
              <a:ext uri="{FF2B5EF4-FFF2-40B4-BE49-F238E27FC236}">
                <a16:creationId xmlns:a16="http://schemas.microsoft.com/office/drawing/2014/main" id="{25EA02A7-3AC3-31E1-A936-FAF1349D2111}"/>
              </a:ext>
            </a:extLst>
          </p:cNvPr>
          <p:cNvSpPr txBox="1">
            <a:spLocks/>
          </p:cNvSpPr>
          <p:nvPr/>
        </p:nvSpPr>
        <p:spPr>
          <a:xfrm>
            <a:off x="838200" y="1597544"/>
            <a:ext cx="3416969" cy="4667251"/>
          </a:xfrm>
          <a:prstGeom prst="rect">
            <a:avLst/>
          </a:prstGeom>
        </p:spPr>
        <p:txBody>
          <a:bodyPr vert="horz" lIns="91440" tIns="45720" rIns="91440" bIns="45720" rtlCol="0">
            <a:normAutofit fontScale="32500" lnSpcReduction="2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lnSpc>
                <a:spcPct val="160000"/>
              </a:lnSpc>
              <a:buFont typeface="Arial" panose="020B0604020202020204" pitchFamily="34" charset="0"/>
              <a:buNone/>
            </a:pPr>
            <a:r>
              <a:rPr lang="en-US" sz="7400" dirty="0"/>
              <a:t>CMP</a:t>
            </a:r>
            <a:endParaRPr lang="en-US" sz="7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6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45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odium 	135 mEq/L</a:t>
            </a:r>
            <a:endParaRPr lang="en-US" sz="45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6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45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otassium 	3.5mEq/L</a:t>
            </a:r>
            <a:endParaRPr lang="en-US" sz="45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6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45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UN		28 mg/dL</a:t>
            </a:r>
            <a:endParaRPr lang="en-US" sz="45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6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45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reatinine	0.87 mg/dL</a:t>
            </a:r>
            <a:endParaRPr lang="en-US" sz="45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6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45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lcium 	8.5 mg/dL</a:t>
            </a:r>
            <a:endParaRPr lang="en-US" sz="45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6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45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hloride 	100 mEq/L </a:t>
            </a:r>
            <a:endParaRPr lang="en-US" sz="45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6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45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icarbonate	24 mEq/L</a:t>
            </a:r>
            <a:endParaRPr lang="en-US" sz="45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6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45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ST		35 U/L</a:t>
            </a:r>
            <a:endParaRPr lang="en-US" sz="45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6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45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LT		45 U/L </a:t>
            </a:r>
            <a:endParaRPr lang="en-US" sz="45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6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45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LP 		55 U/L </a:t>
            </a:r>
            <a:endParaRPr lang="en-US" sz="45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6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45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ilirubin 	&lt;1 mg/dL </a:t>
            </a:r>
            <a:endParaRPr lang="en-US" sz="45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6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45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lbumin 	4.1 g/dL </a:t>
            </a:r>
            <a:endParaRPr lang="en-US" sz="45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indent="0">
              <a:buFont typeface="Arial" panose="020B0604020202020204" pitchFamily="34" charset="0"/>
              <a:buNone/>
            </a:pPr>
            <a:endParaRPr lang="en-US" dirty="0"/>
          </a:p>
          <a:p>
            <a:pPr marL="0" indent="0">
              <a:buFont typeface="Arial" panose="020B0604020202020204" pitchFamily="34" charset="0"/>
              <a:buNone/>
            </a:pPr>
            <a:endParaRPr 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65F035D-561D-5AE0-67A0-FA58F9166F1A}"/>
              </a:ext>
            </a:extLst>
          </p:cNvPr>
          <p:cNvSpPr txBox="1"/>
          <p:nvPr/>
        </p:nvSpPr>
        <p:spPr>
          <a:xfrm>
            <a:off x="5913521" y="1690688"/>
            <a:ext cx="3555332" cy="424731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UA 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pec gravity  	1.002 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ppearance	Cloudy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lor		Yellow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Glucose		Negative 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ilirubin 	Negative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Ketones		Negative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lood 		Negative 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H		7.0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otein		Negative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Urobilinogen 	Negative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C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Leukocytes	Large</a:t>
            </a:r>
            <a:endParaRPr lang="en-US" sz="1800" dirty="0">
              <a:solidFill>
                <a:srgbClr val="C0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Nitrites		Negative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acteria 	Negative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4082150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FE3F21-BE69-1004-EC94-14D88ACD9D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95300" y="56832"/>
            <a:ext cx="10515600" cy="1325563"/>
          </a:xfrm>
        </p:spPr>
        <p:txBody>
          <a:bodyPr>
            <a:normAutofit/>
          </a:bodyPr>
          <a:lstStyle/>
          <a:p>
            <a:pPr algn="ctr"/>
            <a:r>
              <a:rPr lang="en-US" sz="3600" b="1" dirty="0"/>
              <a:t>Transabdominal Ultrasound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442602D-A80A-C5A7-1492-7CE57F516C06}"/>
              </a:ext>
            </a:extLst>
          </p:cNvPr>
          <p:cNvSpPr txBox="1"/>
          <p:nvPr/>
        </p:nvSpPr>
        <p:spPr>
          <a:xfrm>
            <a:off x="418560" y="2376988"/>
            <a:ext cx="254659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Unable to see fetal heart tones </a:t>
            </a:r>
          </a:p>
        </p:txBody>
      </p:sp>
      <p:pic>
        <p:nvPicPr>
          <p:cNvPr id="6" name="video307007">
            <a:hlinkClick r:id="" action="ppaction://media"/>
            <a:extLst>
              <a:ext uri="{FF2B5EF4-FFF2-40B4-BE49-F238E27FC236}">
                <a16:creationId xmlns:a16="http://schemas.microsoft.com/office/drawing/2014/main" id="{C7486885-74AF-F4A7-D8A0-68DFAB343843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2965156" y="1076293"/>
            <a:ext cx="7633167" cy="57248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880384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5046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6"/>
                  </p:tgtEl>
                </p:cond>
              </p:nextCondLst>
            </p:seq>
          </p:childTnLst>
        </p:cTn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2D5E47-05EC-B8CD-434A-E716D8DA38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66712" y="22225"/>
            <a:ext cx="10515600" cy="1325563"/>
          </a:xfrm>
        </p:spPr>
        <p:txBody>
          <a:bodyPr>
            <a:normAutofit/>
          </a:bodyPr>
          <a:lstStyle/>
          <a:p>
            <a:pPr algn="ctr"/>
            <a:r>
              <a:rPr lang="en-US" sz="3600" b="1" dirty="0"/>
              <a:t>Transvaginal Ultrasound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4AAD1D0-7E1B-82EF-49AB-CE1EF8FE7594}"/>
              </a:ext>
            </a:extLst>
          </p:cNvPr>
          <p:cNvSpPr txBox="1"/>
          <p:nvPr/>
        </p:nvSpPr>
        <p:spPr>
          <a:xfrm>
            <a:off x="258556" y="3278166"/>
            <a:ext cx="28610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Fetal heart rate: 127 </a:t>
            </a:r>
          </a:p>
        </p:txBody>
      </p:sp>
      <p:pic>
        <p:nvPicPr>
          <p:cNvPr id="14" name="video269397">
            <a:hlinkClick r:id="" action="ppaction://media"/>
            <a:extLst>
              <a:ext uri="{FF2B5EF4-FFF2-40B4-BE49-F238E27FC236}">
                <a16:creationId xmlns:a16="http://schemas.microsoft.com/office/drawing/2014/main" id="{A7637B0A-9F7E-1F4C-043C-89407A69E1A8}"/>
              </a:ext>
            </a:extLst>
          </p:cNvPr>
          <p:cNvPicPr>
            <a:picLocks noGrp="1" noChangeAspect="1"/>
          </p:cNvPicPr>
          <p:nvPr>
            <p:ph idx="1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3119644" y="1102497"/>
            <a:ext cx="7404921" cy="5553184"/>
          </a:xfrm>
        </p:spPr>
      </p:pic>
    </p:spTree>
    <p:extLst>
      <p:ext uri="{BB962C8B-B14F-4D97-AF65-F5344CB8AC3E}">
        <p14:creationId xmlns:p14="http://schemas.microsoft.com/office/powerpoint/2010/main" val="82258630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6157" fill="hold"/>
                                        <p:tgtEl>
                                          <p:spTgt spid="1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1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1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1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4"/>
                  </p:tgtEl>
                </p:cond>
              </p:nextCondLst>
            </p:seq>
          </p:childTnLst>
        </p:cTn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5" descr="A picture containing diagram&#10;&#10;Description automatically generated">
            <a:extLst>
              <a:ext uri="{FF2B5EF4-FFF2-40B4-BE49-F238E27FC236}">
                <a16:creationId xmlns:a16="http://schemas.microsoft.com/office/drawing/2014/main" id="{B01B8FF0-66DB-8742-29CE-7BF79432D7F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18940" y="371205"/>
            <a:ext cx="8154119" cy="61155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5251361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AD161D-E771-D54E-A7DF-DE0E665016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09600" y="2766218"/>
            <a:ext cx="10972800" cy="1325563"/>
          </a:xfrm>
        </p:spPr>
        <p:txBody>
          <a:bodyPr>
            <a:normAutofit/>
          </a:bodyPr>
          <a:lstStyle/>
          <a:p>
            <a:r>
              <a:rPr lang="en-US" b="1" dirty="0"/>
              <a:t>MRI report: acute uncomplicated appendicitis</a:t>
            </a:r>
          </a:p>
        </p:txBody>
      </p:sp>
    </p:spTree>
    <p:extLst>
      <p:ext uri="{BB962C8B-B14F-4D97-AF65-F5344CB8AC3E}">
        <p14:creationId xmlns:p14="http://schemas.microsoft.com/office/powerpoint/2010/main" val="2690518484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FEE408-BF2E-7FDC-D44F-E4E5E2D01D02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b="1" dirty="0"/>
              <a:t>Case 3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D5056E5-2DEA-3A69-4CCE-AE82242E7914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/>
              <a:t>Vaginal Bleeding in Pregnancy</a:t>
            </a:r>
          </a:p>
        </p:txBody>
      </p:sp>
    </p:spTree>
    <p:extLst>
      <p:ext uri="{BB962C8B-B14F-4D97-AF65-F5344CB8AC3E}">
        <p14:creationId xmlns:p14="http://schemas.microsoft.com/office/powerpoint/2010/main" val="3679234579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21216F-1BEC-8A9D-7BFF-76B010FC54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Labs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F6361A2-8BD3-E557-8A93-6F3BF86137D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051761" y="1978425"/>
            <a:ext cx="4431632" cy="3853280"/>
          </a:xfrm>
        </p:spPr>
        <p:txBody>
          <a:bodyPr>
            <a:normAutofit/>
          </a:bodyPr>
          <a:lstStyle/>
          <a:p>
            <a:pPr marL="0" indent="0">
              <a:lnSpc>
                <a:spcPct val="150000"/>
              </a:lnSpc>
              <a:buNone/>
            </a:pPr>
            <a:r>
              <a:rPr lang="en-US" sz="2400" dirty="0"/>
              <a:t>CBC</a:t>
            </a: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WBC		              10.00 x10</a:t>
            </a:r>
            <a:r>
              <a:rPr lang="en-US" sz="1800" b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/L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C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Hemoglobin 		7.8 g/L</a:t>
            </a:r>
            <a:endParaRPr lang="en-US" sz="1800" dirty="0">
              <a:solidFill>
                <a:srgbClr val="C0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latelets 		250 x10</a:t>
            </a:r>
            <a:r>
              <a:rPr lang="en-US" sz="1800" b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/L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MCV			88 </a:t>
            </a:r>
            <a:r>
              <a:rPr lang="en-US" sz="1800" b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L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RBC			5.5x10</a:t>
            </a:r>
            <a:r>
              <a:rPr lang="en-US" sz="1800" b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12</a:t>
            </a: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/L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Neutrophils 		3.5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Lymphocytes 	               2.5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endParaRPr lang="en-US" dirty="0"/>
          </a:p>
          <a:p>
            <a:pPr marL="0" indent="0">
              <a:buNone/>
            </a:pPr>
            <a:endParaRPr 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F5001BA-83F2-A364-40B9-1E01BCBD0ECC}"/>
              </a:ext>
            </a:extLst>
          </p:cNvPr>
          <p:cNvSpPr txBox="1"/>
          <p:nvPr/>
        </p:nvSpPr>
        <p:spPr>
          <a:xfrm>
            <a:off x="6708608" y="3338115"/>
            <a:ext cx="4499811" cy="56695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C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eta-</a:t>
            </a:r>
            <a:r>
              <a:rPr lang="en-US" sz="1800" b="1" dirty="0" err="1">
                <a:solidFill>
                  <a:srgbClr val="C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hcg</a:t>
            </a:r>
            <a:r>
              <a:rPr lang="en-US" sz="1800" b="1" dirty="0">
                <a:solidFill>
                  <a:srgbClr val="C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	2,500 </a:t>
            </a:r>
            <a:r>
              <a:rPr lang="en-US" sz="1800" b="1" dirty="0" err="1">
                <a:solidFill>
                  <a:srgbClr val="C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mlU</a:t>
            </a:r>
            <a:r>
              <a:rPr lang="en-US" sz="1800" b="1" dirty="0">
                <a:solidFill>
                  <a:srgbClr val="C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/mL</a:t>
            </a:r>
            <a:endParaRPr lang="en-US" sz="1800" dirty="0">
              <a:solidFill>
                <a:srgbClr val="C0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D2505E8-D98C-369B-F924-448876923562}"/>
              </a:ext>
            </a:extLst>
          </p:cNvPr>
          <p:cNvSpPr txBox="1"/>
          <p:nvPr/>
        </p:nvSpPr>
        <p:spPr>
          <a:xfrm>
            <a:off x="6708608" y="2328068"/>
            <a:ext cx="6539162" cy="56695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BO/Rh 	</a:t>
            </a:r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positive/Rh+ 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9D2E86B-04A9-95D0-060F-046E124D3112}"/>
              </a:ext>
            </a:extLst>
          </p:cNvPr>
          <p:cNvSpPr txBox="1"/>
          <p:nvPr/>
        </p:nvSpPr>
        <p:spPr>
          <a:xfrm>
            <a:off x="6708607" y="4632475"/>
            <a:ext cx="4499811" cy="56695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T/INR	             13 seconds / 1.0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75720375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33A2CE-9F34-F7C6-94A3-D34DD326C6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Labs</a:t>
            </a:r>
          </a:p>
        </p:txBody>
      </p:sp>
      <p:sp>
        <p:nvSpPr>
          <p:cNvPr id="5" name="Content Placeholder 2">
            <a:extLst>
              <a:ext uri="{FF2B5EF4-FFF2-40B4-BE49-F238E27FC236}">
                <a16:creationId xmlns:a16="http://schemas.microsoft.com/office/drawing/2014/main" id="{25EA02A7-3AC3-31E1-A936-FAF1349D2111}"/>
              </a:ext>
            </a:extLst>
          </p:cNvPr>
          <p:cNvSpPr txBox="1">
            <a:spLocks/>
          </p:cNvSpPr>
          <p:nvPr/>
        </p:nvSpPr>
        <p:spPr>
          <a:xfrm>
            <a:off x="838200" y="1690688"/>
            <a:ext cx="3416969" cy="4667251"/>
          </a:xfrm>
          <a:prstGeom prst="rect">
            <a:avLst/>
          </a:prstGeom>
        </p:spPr>
        <p:txBody>
          <a:bodyPr vert="horz" lIns="91440" tIns="45720" rIns="91440" bIns="45720" rtlCol="0">
            <a:normAutofit fontScale="32500" lnSpcReduction="2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lnSpc>
                <a:spcPct val="160000"/>
              </a:lnSpc>
              <a:buFont typeface="Arial" panose="020B0604020202020204" pitchFamily="34" charset="0"/>
              <a:buNone/>
            </a:pPr>
            <a:r>
              <a:rPr lang="en-US" sz="7400" dirty="0"/>
              <a:t>CMP</a:t>
            </a:r>
            <a:endParaRPr lang="en-US" sz="7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6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45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odium 	135 mEq/L</a:t>
            </a:r>
            <a:endParaRPr lang="en-US" sz="45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6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45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otassium 	3.5mEq/L</a:t>
            </a:r>
            <a:endParaRPr lang="en-US" sz="45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6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45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UN		28 mg/dL</a:t>
            </a:r>
            <a:endParaRPr lang="en-US" sz="45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6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45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reatinine	0.87 mg/dL</a:t>
            </a:r>
            <a:endParaRPr lang="en-US" sz="45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6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45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lcium 	8.5 mg/dL</a:t>
            </a:r>
            <a:endParaRPr lang="en-US" sz="45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6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45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hloride 	100 mEq/L </a:t>
            </a:r>
            <a:endParaRPr lang="en-US" sz="45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6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45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icarbonate	24 mEq/L</a:t>
            </a:r>
            <a:endParaRPr lang="en-US" sz="45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6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45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ST		35 U/L</a:t>
            </a:r>
            <a:endParaRPr lang="en-US" sz="45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6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45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LT		45 U/L </a:t>
            </a:r>
            <a:endParaRPr lang="en-US" sz="45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6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45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LP 		55 U/L </a:t>
            </a:r>
            <a:endParaRPr lang="en-US" sz="45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6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45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ilirubin 	&lt;1 mg/dL </a:t>
            </a:r>
            <a:endParaRPr lang="en-US" sz="45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6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45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lbumin 	4.1 g/dL </a:t>
            </a:r>
            <a:endParaRPr lang="en-US" sz="45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indent="0">
              <a:buFont typeface="Arial" panose="020B0604020202020204" pitchFamily="34" charset="0"/>
              <a:buNone/>
            </a:pPr>
            <a:endParaRPr lang="en-US" dirty="0"/>
          </a:p>
          <a:p>
            <a:pPr marL="0" indent="0">
              <a:buFont typeface="Arial" panose="020B0604020202020204" pitchFamily="34" charset="0"/>
              <a:buNone/>
            </a:pPr>
            <a:endParaRPr 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65F035D-561D-5AE0-67A0-FA58F9166F1A}"/>
              </a:ext>
            </a:extLst>
          </p:cNvPr>
          <p:cNvSpPr txBox="1"/>
          <p:nvPr/>
        </p:nvSpPr>
        <p:spPr>
          <a:xfrm>
            <a:off x="6026818" y="1900655"/>
            <a:ext cx="3555332" cy="424731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UA 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pec gravity  	1.002 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ppearance	Cloudy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C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lor		Red</a:t>
            </a:r>
            <a:endParaRPr lang="en-US" sz="1800" dirty="0">
              <a:solidFill>
                <a:srgbClr val="C0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Glucose		Negative 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ilirubin 	Negative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Ketones		Negative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C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lood 		Large </a:t>
            </a:r>
            <a:endParaRPr lang="en-US" sz="1800" dirty="0">
              <a:solidFill>
                <a:srgbClr val="C0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H		7.0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otein		Negative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Urobilinogen 	Negative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Leukocytes	Negative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Nitrites		Negative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acteria 	Negative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82242751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4DDBB0-1D25-06BE-23A3-8E80BE3BA1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0"/>
            <a:ext cx="10515600" cy="1325563"/>
          </a:xfrm>
        </p:spPr>
        <p:txBody>
          <a:bodyPr>
            <a:normAutofit/>
          </a:bodyPr>
          <a:lstStyle/>
          <a:p>
            <a:pPr algn="ctr"/>
            <a:r>
              <a:rPr lang="en-US" sz="3600" b="1" dirty="0"/>
              <a:t>Transabdominal Ultrasound</a:t>
            </a:r>
          </a:p>
        </p:txBody>
      </p:sp>
      <p:pic>
        <p:nvPicPr>
          <p:cNvPr id="4" name="video307006">
            <a:hlinkClick r:id="" action="ppaction://media"/>
            <a:extLst>
              <a:ext uri="{FF2B5EF4-FFF2-40B4-BE49-F238E27FC236}">
                <a16:creationId xmlns:a16="http://schemas.microsoft.com/office/drawing/2014/main" id="{D4D76255-4E10-C262-B54C-04B705633BA5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2391460" y="1093693"/>
            <a:ext cx="7409080" cy="55568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9112033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5167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OUL">
            <a:hlinkClick r:id="" action="ppaction://media"/>
            <a:extLst>
              <a:ext uri="{FF2B5EF4-FFF2-40B4-BE49-F238E27FC236}">
                <a16:creationId xmlns:a16="http://schemas.microsoft.com/office/drawing/2014/main" id="{A4F760ED-9029-4989-FB22-32CC39B1078B}"/>
              </a:ext>
            </a:extLst>
          </p:cNvPr>
          <p:cNvPicPr>
            <a:picLocks noGrp="1" noChangeAspect="1"/>
          </p:cNvPicPr>
          <p:nvPr>
            <p:ph idx="1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2184904" y="1036141"/>
            <a:ext cx="7822192" cy="564936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C32D7635-C1C0-69FA-DECF-FAF97825F6E4}"/>
              </a:ext>
            </a:extLst>
          </p:cNvPr>
          <p:cNvSpPr txBox="1"/>
          <p:nvPr/>
        </p:nvSpPr>
        <p:spPr>
          <a:xfrm>
            <a:off x="3046379" y="172498"/>
            <a:ext cx="6099242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4400" b="1" dirty="0">
                <a:latin typeface="+mj-lt"/>
              </a:rPr>
              <a:t>Transvaginal Ultrasound </a:t>
            </a:r>
          </a:p>
        </p:txBody>
      </p:sp>
    </p:spTree>
    <p:extLst>
      <p:ext uri="{BB962C8B-B14F-4D97-AF65-F5344CB8AC3E}">
        <p14:creationId xmlns:p14="http://schemas.microsoft.com/office/powerpoint/2010/main" val="107955782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6200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12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FEE408-BF2E-7FDC-D44F-E4E5E2D01D02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b="1" dirty="0"/>
              <a:t>Case 1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D5056E5-2DEA-3A69-4CCE-AE82242E7914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/>
              <a:t>Abdominal Pain in Pregnancy</a:t>
            </a:r>
          </a:p>
        </p:txBody>
      </p:sp>
    </p:spTree>
    <p:extLst>
      <p:ext uri="{BB962C8B-B14F-4D97-AF65-F5344CB8AC3E}">
        <p14:creationId xmlns:p14="http://schemas.microsoft.com/office/powerpoint/2010/main" val="1790357576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01BEC3-A4C4-36B3-024B-1C3EF9B990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199" y="-152400"/>
            <a:ext cx="10515600" cy="1325563"/>
          </a:xfrm>
        </p:spPr>
        <p:txBody>
          <a:bodyPr>
            <a:normAutofit/>
          </a:bodyPr>
          <a:lstStyle/>
          <a:p>
            <a:pPr algn="ctr"/>
            <a:r>
              <a:rPr lang="en-US" sz="3600" b="1" dirty="0"/>
              <a:t>FAST EXAM</a:t>
            </a:r>
          </a:p>
        </p:txBody>
      </p:sp>
      <p:pic>
        <p:nvPicPr>
          <p:cNvPr id="6" name="video307010">
            <a:hlinkClick r:id="" action="ppaction://media"/>
            <a:extLst>
              <a:ext uri="{FF2B5EF4-FFF2-40B4-BE49-F238E27FC236}">
                <a16:creationId xmlns:a16="http://schemas.microsoft.com/office/drawing/2014/main" id="{C70E0DF6-0311-85AE-486C-CFC0A6C9E007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2153910" y="819360"/>
            <a:ext cx="7884178" cy="59131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1728643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5046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6"/>
                  </p:tgtEl>
                </p:cond>
              </p:nextCondLst>
            </p:seq>
          </p:childTnLst>
        </p:cTn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01BEC3-A4C4-36B3-024B-1C3EF9B990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199" y="-152400"/>
            <a:ext cx="10515600" cy="1325563"/>
          </a:xfrm>
        </p:spPr>
        <p:txBody>
          <a:bodyPr>
            <a:normAutofit/>
          </a:bodyPr>
          <a:lstStyle/>
          <a:p>
            <a:pPr algn="ctr"/>
            <a:r>
              <a:rPr lang="en-US" sz="3600" b="1" dirty="0"/>
              <a:t>FAST EXAM</a:t>
            </a:r>
          </a:p>
        </p:txBody>
      </p:sp>
      <p:pic>
        <p:nvPicPr>
          <p:cNvPr id="3" name="video307009">
            <a:hlinkClick r:id="" action="ppaction://media"/>
            <a:extLst>
              <a:ext uri="{FF2B5EF4-FFF2-40B4-BE49-F238E27FC236}">
                <a16:creationId xmlns:a16="http://schemas.microsoft.com/office/drawing/2014/main" id="{A490CDDB-CBD9-7077-F5A7-23938E779932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2206904" y="867755"/>
            <a:ext cx="7778190" cy="58336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3538851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5046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21216F-1BEC-8A9D-7BFF-76B010FC54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Labs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F6361A2-8BD3-E557-8A93-6F3BF86137D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285375" y="1694950"/>
            <a:ext cx="4431632" cy="3853280"/>
          </a:xfrm>
        </p:spPr>
        <p:txBody>
          <a:bodyPr>
            <a:normAutofit lnSpcReduction="10000"/>
          </a:bodyPr>
          <a:lstStyle/>
          <a:p>
            <a:pPr marL="0" indent="0">
              <a:lnSpc>
                <a:spcPct val="150000"/>
              </a:lnSpc>
              <a:buNone/>
            </a:pPr>
            <a:r>
              <a:rPr lang="en-US" sz="2400" b="1" dirty="0"/>
              <a:t>CBC</a:t>
            </a: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WBC		              10.00 x10</a:t>
            </a:r>
            <a:r>
              <a:rPr lang="en-US" sz="1800" b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/L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C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Hemoglobin 		9.8 g/L</a:t>
            </a: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kern="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ematocrit </a:t>
            </a:r>
            <a:r>
              <a:rPr lang="en-US" sz="1800" b="1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		</a:t>
            </a:r>
            <a:r>
              <a:rPr lang="en-US" sz="1800" b="1" kern="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0.5%</a:t>
            </a:r>
            <a:endParaRPr lang="en-US" sz="1800" dirty="0">
              <a:solidFill>
                <a:srgbClr val="C00000"/>
              </a:solidFill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latelets 		250 x10</a:t>
            </a:r>
            <a:r>
              <a:rPr lang="en-US" sz="1800" b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/L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C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MCV			67 </a:t>
            </a:r>
            <a:r>
              <a:rPr lang="en-US" sz="1800" b="1" dirty="0" err="1">
                <a:solidFill>
                  <a:srgbClr val="C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L</a:t>
            </a:r>
            <a:endParaRPr lang="en-US" sz="1800" dirty="0">
              <a:solidFill>
                <a:srgbClr val="C0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RBC			5.5x10</a:t>
            </a:r>
            <a:r>
              <a:rPr lang="en-US" sz="1800" b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12</a:t>
            </a: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/L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Neutrophils 		3.5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Lymphocytes 	              2.5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endParaRPr lang="en-US" dirty="0"/>
          </a:p>
          <a:p>
            <a:pPr marL="0" indent="0">
              <a:buNone/>
            </a:pPr>
            <a:endParaRPr 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F5001BA-83F2-A364-40B9-1E01BCBD0ECC}"/>
              </a:ext>
            </a:extLst>
          </p:cNvPr>
          <p:cNvSpPr txBox="1"/>
          <p:nvPr/>
        </p:nvSpPr>
        <p:spPr>
          <a:xfrm>
            <a:off x="6708608" y="3338115"/>
            <a:ext cx="4499811" cy="56695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C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-</a:t>
            </a:r>
            <a:r>
              <a:rPr lang="en-US" sz="1800" b="1" dirty="0" err="1">
                <a:solidFill>
                  <a:srgbClr val="C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hcg</a:t>
            </a:r>
            <a:r>
              <a:rPr lang="en-US" sz="1800" b="1" dirty="0">
                <a:solidFill>
                  <a:srgbClr val="C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:	               4,500 </a:t>
            </a:r>
            <a:r>
              <a:rPr lang="en-US" sz="1800" b="1" dirty="0" err="1">
                <a:solidFill>
                  <a:srgbClr val="C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mlU</a:t>
            </a:r>
            <a:r>
              <a:rPr lang="en-US" sz="1800" b="1" dirty="0">
                <a:solidFill>
                  <a:srgbClr val="C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/mL</a:t>
            </a:r>
            <a:endParaRPr lang="en-US" sz="1800" dirty="0">
              <a:solidFill>
                <a:srgbClr val="C0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D2505E8-D98C-369B-F924-448876923562}"/>
              </a:ext>
            </a:extLst>
          </p:cNvPr>
          <p:cNvSpPr txBox="1"/>
          <p:nvPr/>
        </p:nvSpPr>
        <p:spPr>
          <a:xfrm>
            <a:off x="6708608" y="2328068"/>
            <a:ext cx="6539162" cy="56695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BO/Rh 	O positive/Rh+ 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2133481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33A2CE-9F34-F7C6-94A3-D34DD326C6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69018" y="147511"/>
            <a:ext cx="1526710" cy="1325563"/>
          </a:xfrm>
        </p:spPr>
        <p:txBody>
          <a:bodyPr/>
          <a:lstStyle/>
          <a:p>
            <a:r>
              <a:rPr lang="en-US" b="1" dirty="0"/>
              <a:t>Labs</a:t>
            </a:r>
          </a:p>
        </p:txBody>
      </p:sp>
      <p:sp>
        <p:nvSpPr>
          <p:cNvPr id="5" name="Content Placeholder 2">
            <a:extLst>
              <a:ext uri="{FF2B5EF4-FFF2-40B4-BE49-F238E27FC236}">
                <a16:creationId xmlns:a16="http://schemas.microsoft.com/office/drawing/2014/main" id="{25EA02A7-3AC3-31E1-A936-FAF1349D2111}"/>
              </a:ext>
            </a:extLst>
          </p:cNvPr>
          <p:cNvSpPr txBox="1">
            <a:spLocks/>
          </p:cNvSpPr>
          <p:nvPr/>
        </p:nvSpPr>
        <p:spPr>
          <a:xfrm>
            <a:off x="901365" y="1789018"/>
            <a:ext cx="3416969" cy="4667251"/>
          </a:xfrm>
          <a:prstGeom prst="rect">
            <a:avLst/>
          </a:prstGeom>
        </p:spPr>
        <p:txBody>
          <a:bodyPr vert="horz" lIns="91440" tIns="45720" rIns="91440" bIns="45720" rtlCol="0">
            <a:normAutofit fontScale="25000" lnSpcReduction="2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lnSpc>
                <a:spcPct val="160000"/>
              </a:lnSpc>
              <a:buFont typeface="Arial" panose="020B0604020202020204" pitchFamily="34" charset="0"/>
              <a:buNone/>
            </a:pPr>
            <a:r>
              <a:rPr lang="en-US" sz="7400" b="1" dirty="0"/>
              <a:t>CMP</a:t>
            </a:r>
            <a:endParaRPr lang="en-US" sz="7400" b="1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6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7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odium 	135 mEq/L</a:t>
            </a:r>
            <a:endParaRPr lang="en-US" sz="7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>
              <a:lnSpc>
                <a:spcPct val="16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7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otassium 	3.5mEq/L</a:t>
            </a:r>
            <a:endParaRPr lang="en-US" sz="7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>
              <a:lnSpc>
                <a:spcPct val="16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7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UN		20 mg/dL</a:t>
            </a:r>
            <a:endParaRPr lang="en-US" sz="7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>
              <a:lnSpc>
                <a:spcPct val="16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7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reatinine	0.6 mg/dL</a:t>
            </a:r>
            <a:endParaRPr lang="en-US" sz="7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>
              <a:lnSpc>
                <a:spcPct val="16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7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alcium 	8.5 mg/dL</a:t>
            </a:r>
            <a:endParaRPr lang="en-US" sz="7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>
              <a:lnSpc>
                <a:spcPct val="16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7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hloride 	100 mEq/L </a:t>
            </a:r>
            <a:endParaRPr lang="en-US" sz="7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>
              <a:lnSpc>
                <a:spcPct val="16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7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icarbonate	24 mEq/L</a:t>
            </a:r>
            <a:endParaRPr lang="en-US" sz="7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>
              <a:lnSpc>
                <a:spcPct val="16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7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ST		35 U/L</a:t>
            </a:r>
            <a:endParaRPr lang="en-US" sz="7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>
              <a:lnSpc>
                <a:spcPct val="16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7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LT		45 U/L </a:t>
            </a:r>
            <a:endParaRPr lang="en-US" sz="7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>
              <a:lnSpc>
                <a:spcPct val="16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7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LP 		55 U/L </a:t>
            </a:r>
            <a:endParaRPr lang="en-US" sz="7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>
              <a:lnSpc>
                <a:spcPct val="16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7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ilirubin 	&lt;1 mg/dL </a:t>
            </a:r>
            <a:endParaRPr lang="en-US" sz="7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>
              <a:lnSpc>
                <a:spcPct val="16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7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lbumin 	4.1 g/dL </a:t>
            </a:r>
            <a:endParaRPr lang="en-US" sz="7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indent="0">
              <a:buFont typeface="Arial" panose="020B0604020202020204" pitchFamily="34" charset="0"/>
              <a:buNone/>
            </a:pPr>
            <a:endParaRPr lang="en-US" sz="7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buFont typeface="Arial" panose="020B0604020202020204" pitchFamily="34" charset="0"/>
              <a:buNone/>
            </a:pPr>
            <a:endParaRPr 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65F035D-561D-5AE0-67A0-FA58F9166F1A}"/>
              </a:ext>
            </a:extLst>
          </p:cNvPr>
          <p:cNvSpPr txBox="1"/>
          <p:nvPr/>
        </p:nvSpPr>
        <p:spPr>
          <a:xfrm>
            <a:off x="6096000" y="1789018"/>
            <a:ext cx="3555332" cy="424731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UA 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pec gravity  	1.010 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ppearance	Clear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lor		Yellow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Glucose		Negative 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ilirubin 	Negative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Ketones		Negative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lood 		None 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H		7.0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otein		Negative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Urobilinogen 	Negative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Leukocytes	Negative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Nitrites		Negative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acteria 	Negative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6330186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4DDBB0-1D25-06BE-23A3-8E80BE3BA1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21497" y="0"/>
            <a:ext cx="10515600" cy="1325563"/>
          </a:xfrm>
        </p:spPr>
        <p:txBody>
          <a:bodyPr>
            <a:normAutofit/>
          </a:bodyPr>
          <a:lstStyle/>
          <a:p>
            <a:pPr algn="ctr"/>
            <a:r>
              <a:rPr lang="en-US" sz="3600" b="1" dirty="0"/>
              <a:t>Transabdominal Ultrasound</a:t>
            </a:r>
          </a:p>
        </p:txBody>
      </p:sp>
      <p:pic>
        <p:nvPicPr>
          <p:cNvPr id="4" name="video307007">
            <a:hlinkClick r:id="" action="ppaction://media"/>
            <a:extLst>
              <a:ext uri="{FF2B5EF4-FFF2-40B4-BE49-F238E27FC236}">
                <a16:creationId xmlns:a16="http://schemas.microsoft.com/office/drawing/2014/main" id="{C8C04BB6-CFC0-44E4-D482-203D8CFD4C3A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2097741" y="1074550"/>
            <a:ext cx="7376583" cy="55324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4058651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5046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01BEC3-A4C4-36B3-024B-1C3EF9B990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58604" y="-222422"/>
            <a:ext cx="10515600" cy="1325563"/>
          </a:xfrm>
        </p:spPr>
        <p:txBody>
          <a:bodyPr>
            <a:normAutofit/>
          </a:bodyPr>
          <a:lstStyle/>
          <a:p>
            <a:pPr algn="ctr"/>
            <a:r>
              <a:rPr lang="en-US" sz="3600" b="1" dirty="0"/>
              <a:t>Transvaginal Ultrasound 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4815D3F1-7C23-5289-BE2F-6DD4BCCF076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11864" y="790099"/>
            <a:ext cx="7768272" cy="58578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0410383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UP">
            <a:hlinkClick r:id="" action="ppaction://media"/>
            <a:extLst>
              <a:ext uri="{FF2B5EF4-FFF2-40B4-BE49-F238E27FC236}">
                <a16:creationId xmlns:a16="http://schemas.microsoft.com/office/drawing/2014/main" id="{C278248B-4AD9-C236-0BAF-2B47C862650E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2038393" y="385794"/>
            <a:ext cx="8115214" cy="60864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2191899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6125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12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</p:childTnLst>
        </p:cTn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FEE408-BF2E-7FDC-D44F-E4E5E2D01D02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b="1" dirty="0"/>
              <a:t>Case 2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D5056E5-2DEA-3A69-4CCE-AE82242E7914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/>
              <a:t>Right Lower Quadrant Pain in Pregnancy</a:t>
            </a:r>
          </a:p>
        </p:txBody>
      </p:sp>
    </p:spTree>
    <p:extLst>
      <p:ext uri="{BB962C8B-B14F-4D97-AF65-F5344CB8AC3E}">
        <p14:creationId xmlns:p14="http://schemas.microsoft.com/office/powerpoint/2010/main" val="104365174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21216F-1BEC-8A9D-7BFF-76B010FC54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Labs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F6361A2-8BD3-E557-8A93-6F3BF86137D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285375" y="1694950"/>
            <a:ext cx="4431632" cy="3853280"/>
          </a:xfrm>
        </p:spPr>
        <p:txBody>
          <a:bodyPr>
            <a:normAutofit/>
          </a:bodyPr>
          <a:lstStyle/>
          <a:p>
            <a:pPr marL="0" indent="0">
              <a:lnSpc>
                <a:spcPct val="150000"/>
              </a:lnSpc>
              <a:buNone/>
            </a:pPr>
            <a:r>
              <a:rPr lang="en-US" sz="2400" dirty="0"/>
              <a:t>CBC</a:t>
            </a: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C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WBC		              15.00 x10</a:t>
            </a:r>
            <a:r>
              <a:rPr lang="en-US" sz="1800" b="1" baseline="30000" dirty="0">
                <a:solidFill>
                  <a:srgbClr val="C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r>
              <a:rPr lang="en-US" sz="1800" b="1" dirty="0">
                <a:solidFill>
                  <a:srgbClr val="C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/L</a:t>
            </a:r>
            <a:endParaRPr lang="en-US" sz="1800" dirty="0">
              <a:solidFill>
                <a:srgbClr val="C0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Hemoglobin 		12.8 g/L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latelets 		250 x10</a:t>
            </a:r>
            <a:r>
              <a:rPr lang="en-US" sz="1800" b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/L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MCV			88 </a:t>
            </a:r>
            <a:r>
              <a:rPr lang="en-US" sz="1800" b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L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RBC			5.5x10</a:t>
            </a:r>
            <a:r>
              <a:rPr lang="en-US" sz="1800" b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12</a:t>
            </a: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/L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Neutrophils 		3.5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Lymphocytes 	              2.5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endParaRPr lang="en-US" dirty="0"/>
          </a:p>
          <a:p>
            <a:pPr marL="0" indent="0">
              <a:buNone/>
            </a:pPr>
            <a:endParaRPr 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F5001BA-83F2-A364-40B9-1E01BCBD0ECC}"/>
              </a:ext>
            </a:extLst>
          </p:cNvPr>
          <p:cNvSpPr txBox="1"/>
          <p:nvPr/>
        </p:nvSpPr>
        <p:spPr>
          <a:xfrm>
            <a:off x="6708608" y="3338115"/>
            <a:ext cx="4499811" cy="56695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C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-</a:t>
            </a:r>
            <a:r>
              <a:rPr lang="en-US" sz="1800" b="1" dirty="0" err="1">
                <a:solidFill>
                  <a:srgbClr val="C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hcg</a:t>
            </a:r>
            <a:r>
              <a:rPr lang="en-US" sz="1800" b="1" dirty="0">
                <a:solidFill>
                  <a:srgbClr val="C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	              50,</a:t>
            </a:r>
            <a:r>
              <a:rPr lang="en-US" b="1" dirty="0">
                <a:solidFill>
                  <a:srgbClr val="C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800" b="1" dirty="0">
                <a:solidFill>
                  <a:srgbClr val="C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50 </a:t>
            </a:r>
            <a:r>
              <a:rPr lang="en-US" sz="1800" b="1" dirty="0" err="1">
                <a:solidFill>
                  <a:srgbClr val="C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mlU</a:t>
            </a:r>
            <a:r>
              <a:rPr lang="en-US" sz="1800" b="1" dirty="0">
                <a:solidFill>
                  <a:srgbClr val="C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/mL</a:t>
            </a:r>
            <a:endParaRPr lang="en-US" sz="1800" dirty="0">
              <a:solidFill>
                <a:srgbClr val="C0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D2505E8-D98C-369B-F924-448876923562}"/>
              </a:ext>
            </a:extLst>
          </p:cNvPr>
          <p:cNvSpPr txBox="1"/>
          <p:nvPr/>
        </p:nvSpPr>
        <p:spPr>
          <a:xfrm>
            <a:off x="6708608" y="2328068"/>
            <a:ext cx="6539162" cy="56695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BO/Rh 	O positive/Rh+ 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9D2E86B-04A9-95D0-060F-046E124D3112}"/>
              </a:ext>
            </a:extLst>
          </p:cNvPr>
          <p:cNvSpPr txBox="1"/>
          <p:nvPr/>
        </p:nvSpPr>
        <p:spPr>
          <a:xfrm>
            <a:off x="6708607" y="4185003"/>
            <a:ext cx="4499811" cy="56695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T/INR	             13 seconds / 1.0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733778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965</TotalTime>
  <Words>725</Words>
  <Application>Microsoft Macintosh PowerPoint</Application>
  <PresentationFormat>Widescreen</PresentationFormat>
  <Paragraphs>175</Paragraphs>
  <Slides>21</Slides>
  <Notes>12</Notes>
  <HiddenSlides>0</HiddenSlides>
  <MMClips>8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1</vt:i4>
      </vt:variant>
    </vt:vector>
  </HeadingPairs>
  <TitlesOfParts>
    <vt:vector size="27" baseType="lpstr">
      <vt:lpstr>Arial</vt:lpstr>
      <vt:lpstr>Calibri</vt:lpstr>
      <vt:lpstr>Calibri Light</vt:lpstr>
      <vt:lpstr>Helvetica Neue</vt:lpstr>
      <vt:lpstr>Times New Roman</vt:lpstr>
      <vt:lpstr>Office Theme</vt:lpstr>
      <vt:lpstr>Transvaginal Ultrasound Simulation </vt:lpstr>
      <vt:lpstr>Case 1</vt:lpstr>
      <vt:lpstr>Labs </vt:lpstr>
      <vt:lpstr>Labs</vt:lpstr>
      <vt:lpstr>Transabdominal Ultrasound</vt:lpstr>
      <vt:lpstr>Transvaginal Ultrasound </vt:lpstr>
      <vt:lpstr>PowerPoint Presentation</vt:lpstr>
      <vt:lpstr>Case 2</vt:lpstr>
      <vt:lpstr>Labs </vt:lpstr>
      <vt:lpstr>Labs</vt:lpstr>
      <vt:lpstr>Transabdominal Ultrasound</vt:lpstr>
      <vt:lpstr>Transvaginal Ultrasound </vt:lpstr>
      <vt:lpstr>PowerPoint Presentation</vt:lpstr>
      <vt:lpstr>MRI report: acute uncomplicated appendicitis</vt:lpstr>
      <vt:lpstr>Case 3</vt:lpstr>
      <vt:lpstr>Labs </vt:lpstr>
      <vt:lpstr>Labs</vt:lpstr>
      <vt:lpstr>Transabdominal Ultrasound</vt:lpstr>
      <vt:lpstr>PowerPoint Presentation</vt:lpstr>
      <vt:lpstr>FAST EXAM</vt:lpstr>
      <vt:lpstr>FAST EXAM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imulation Day </dc:title>
  <dc:creator>Katrina Lettang</dc:creator>
  <cp:lastModifiedBy>Wray, Alisa</cp:lastModifiedBy>
  <cp:revision>24</cp:revision>
  <dcterms:created xsi:type="dcterms:W3CDTF">2023-02-07T20:20:07Z</dcterms:created>
  <dcterms:modified xsi:type="dcterms:W3CDTF">2024-07-28T00:41:40Z</dcterms:modified>
</cp:coreProperties>
</file>